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</p:sldIdLst>
  <p:sldSz cx="9144000" cy="611981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8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21" d="100"/>
          <a:sy n="121" d="100"/>
        </p:scale>
        <p:origin x="1314" y="102"/>
      </p:cViewPr>
      <p:guideLst>
        <p:guide orient="horz" pos="1928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1901109"/>
            <a:ext cx="7772400" cy="131179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467895"/>
            <a:ext cx="6400800" cy="156395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45078"/>
            <a:ext cx="2057400" cy="5221674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45078"/>
            <a:ext cx="6019800" cy="5221674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3932548"/>
            <a:ext cx="7772400" cy="1215464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593839"/>
            <a:ext cx="7772400" cy="133870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427958"/>
            <a:ext cx="4038600" cy="40387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427958"/>
            <a:ext cx="4038600" cy="403879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369875"/>
            <a:ext cx="4040188" cy="57089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1940775"/>
            <a:ext cx="4040188" cy="352597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30" y="1369875"/>
            <a:ext cx="4041775" cy="57089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30" y="1940775"/>
            <a:ext cx="4041775" cy="352597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5" y="243659"/>
            <a:ext cx="3008313" cy="10369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43660"/>
            <a:ext cx="5111750" cy="522309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5" y="1280628"/>
            <a:ext cx="3008313" cy="418612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283869"/>
            <a:ext cx="5486400" cy="50573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546818"/>
            <a:ext cx="5486400" cy="367188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4789604"/>
            <a:ext cx="5486400" cy="71822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45078"/>
            <a:ext cx="8229600" cy="10199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427958"/>
            <a:ext cx="8229600" cy="40387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5672162"/>
            <a:ext cx="2133600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15/01/20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5672162"/>
            <a:ext cx="2895600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5672162"/>
            <a:ext cx="2133600" cy="3258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CuadroTexto"/>
          <p:cNvSpPr txBox="1"/>
          <p:nvPr/>
        </p:nvSpPr>
        <p:spPr>
          <a:xfrm>
            <a:off x="323528" y="37058"/>
            <a:ext cx="71287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3.4 (1/3): Alignment in the </a:t>
            </a:r>
            <a:r>
              <a:rPr lang="en-US" dirty="0" err="1"/>
              <a:t>Sanyueli</a:t>
            </a:r>
            <a:r>
              <a:rPr lang="en-US" dirty="0"/>
              <a:t> MYB10 reg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EF35AB6A-3D33-46E0-88A4-A8A0B33029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30634"/>
            <a:ext cx="9144000" cy="51816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39A0018-7520-466B-B2A2-8FEB195C70A4}"/>
              </a:ext>
            </a:extLst>
          </p:cNvPr>
          <p:cNvSpPr txBox="1"/>
          <p:nvPr/>
        </p:nvSpPr>
        <p:spPr>
          <a:xfrm rot="19800000">
            <a:off x="548048" y="760989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3</a:t>
            </a:r>
            <a:endParaRPr lang="en-US" sz="10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CE39FE-E11D-4040-AC75-DB129872B6F8}"/>
              </a:ext>
            </a:extLst>
          </p:cNvPr>
          <p:cNvSpPr txBox="1"/>
          <p:nvPr/>
        </p:nvSpPr>
        <p:spPr>
          <a:xfrm rot="19800000">
            <a:off x="1095706" y="760989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1</a:t>
            </a:r>
            <a:endParaRPr lang="en-US" sz="1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6B79F29-CBCC-4072-B39A-980C8642D4C8}"/>
              </a:ext>
            </a:extLst>
          </p:cNvPr>
          <p:cNvSpPr txBox="1"/>
          <p:nvPr/>
        </p:nvSpPr>
        <p:spPr>
          <a:xfrm rot="19800000">
            <a:off x="6164672" y="760989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2</a:t>
            </a:r>
            <a:endParaRPr lang="en-US" sz="10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A2CB57-38AD-4E9C-A2B0-A6AB955B9A73}"/>
              </a:ext>
            </a:extLst>
          </p:cNvPr>
          <p:cNvSpPr txBox="1"/>
          <p:nvPr/>
        </p:nvSpPr>
        <p:spPr>
          <a:xfrm rot="19800000">
            <a:off x="6849507" y="760989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1</a:t>
            </a:r>
            <a:endParaRPr lang="en-US" sz="10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E4DA32F-B39D-4A35-9844-6176D2DF566A}"/>
              </a:ext>
            </a:extLst>
          </p:cNvPr>
          <p:cNvSpPr txBox="1"/>
          <p:nvPr/>
        </p:nvSpPr>
        <p:spPr>
          <a:xfrm rot="19800000">
            <a:off x="7397164" y="760989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2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346324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323528" y="37058"/>
            <a:ext cx="84249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3.4 (2/3): Alignment in the Zhongli-1 MYB10 regi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C37721E-21BF-4F4A-9BA7-D6CAAA1B70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30634"/>
            <a:ext cx="9144000" cy="51816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B8ABF9B-AA2F-49DF-AF15-15659EBB1BDD}"/>
              </a:ext>
            </a:extLst>
          </p:cNvPr>
          <p:cNvSpPr txBox="1"/>
          <p:nvPr/>
        </p:nvSpPr>
        <p:spPr>
          <a:xfrm rot="19800000">
            <a:off x="836078" y="792811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2</a:t>
            </a:r>
            <a:endParaRPr lang="en-US" sz="10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AA9116F-9DF4-4A89-AD77-E8F397A59F29}"/>
              </a:ext>
            </a:extLst>
          </p:cNvPr>
          <p:cNvSpPr txBox="1"/>
          <p:nvPr/>
        </p:nvSpPr>
        <p:spPr>
          <a:xfrm rot="19800000">
            <a:off x="1556160" y="792811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2</a:t>
            </a:r>
            <a:endParaRPr lang="en-US" sz="1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3E523F1-FA4E-484A-A29A-58B58933C594}"/>
              </a:ext>
            </a:extLst>
          </p:cNvPr>
          <p:cNvSpPr txBox="1"/>
          <p:nvPr/>
        </p:nvSpPr>
        <p:spPr>
          <a:xfrm rot="19800000">
            <a:off x="5354328" y="792811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1</a:t>
            </a:r>
            <a:endParaRPr lang="en-US" sz="10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EE2E853-68B6-4FE6-8F2C-5AB2FEE58435}"/>
              </a:ext>
            </a:extLst>
          </p:cNvPr>
          <p:cNvSpPr txBox="1"/>
          <p:nvPr/>
        </p:nvSpPr>
        <p:spPr>
          <a:xfrm rot="19800000">
            <a:off x="5771682" y="792811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2</a:t>
            </a:r>
            <a:endParaRPr lang="en-US" sz="10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AB90642-AD69-4D7E-8AF7-D0EF9ED7CAC3}"/>
              </a:ext>
            </a:extLst>
          </p:cNvPr>
          <p:cNvSpPr txBox="1"/>
          <p:nvPr/>
        </p:nvSpPr>
        <p:spPr>
          <a:xfrm rot="19800000">
            <a:off x="6003664" y="792811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1</a:t>
            </a:r>
            <a:endParaRPr lang="en-US" sz="10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821C98-B380-4417-9059-A34CE883A17B}"/>
              </a:ext>
            </a:extLst>
          </p:cNvPr>
          <p:cNvSpPr txBox="1"/>
          <p:nvPr/>
        </p:nvSpPr>
        <p:spPr>
          <a:xfrm rot="19800000">
            <a:off x="6443509" y="792811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2</a:t>
            </a:r>
            <a:endParaRPr lang="en-US" sz="10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6F9B3B3-BE20-4BD1-AED3-EC77AA9F2436}"/>
              </a:ext>
            </a:extLst>
          </p:cNvPr>
          <p:cNvSpPr txBox="1"/>
          <p:nvPr/>
        </p:nvSpPr>
        <p:spPr>
          <a:xfrm rot="19800000">
            <a:off x="7640325" y="792811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1</a:t>
            </a:r>
            <a:endParaRPr lang="en-US" sz="1000" b="1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1E61D46-DE4F-4AEB-80A4-AB4234F9D94C}"/>
              </a:ext>
            </a:extLst>
          </p:cNvPr>
          <p:cNvSpPr txBox="1"/>
          <p:nvPr/>
        </p:nvSpPr>
        <p:spPr>
          <a:xfrm rot="19800000">
            <a:off x="8306202" y="792811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3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0282618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4 CuadroTexto"/>
          <p:cNvSpPr txBox="1"/>
          <p:nvPr/>
        </p:nvSpPr>
        <p:spPr>
          <a:xfrm>
            <a:off x="323528" y="37058"/>
            <a:ext cx="8064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3.4 (3/3): Alignment in the Zhongli-2 MYB10 region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DAA8253-519E-4DA5-AD63-A478C252F4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30634"/>
            <a:ext cx="9144000" cy="51816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53003FE-CE67-47E4-8A8F-E16C4382014D}"/>
              </a:ext>
            </a:extLst>
          </p:cNvPr>
          <p:cNvSpPr txBox="1"/>
          <p:nvPr/>
        </p:nvSpPr>
        <p:spPr>
          <a:xfrm rot="19800000">
            <a:off x="548048" y="777126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3</a:t>
            </a:r>
            <a:endParaRPr lang="en-US" sz="10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0E1B8E9-B444-44B8-8171-2F9F5CB16FF6}"/>
              </a:ext>
            </a:extLst>
          </p:cNvPr>
          <p:cNvSpPr txBox="1"/>
          <p:nvPr/>
        </p:nvSpPr>
        <p:spPr>
          <a:xfrm rot="19800000">
            <a:off x="1357127" y="777126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1</a:t>
            </a:r>
            <a:endParaRPr lang="en-US" sz="1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1E0384C-3A15-4466-BDFA-8DF0E7FCA3B9}"/>
              </a:ext>
            </a:extLst>
          </p:cNvPr>
          <p:cNvSpPr txBox="1"/>
          <p:nvPr/>
        </p:nvSpPr>
        <p:spPr>
          <a:xfrm rot="19800000">
            <a:off x="5876639" y="777126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2</a:t>
            </a:r>
            <a:endParaRPr lang="en-US" sz="1000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04C95D5-29CE-44BD-92DC-B20EF34D500B}"/>
              </a:ext>
            </a:extLst>
          </p:cNvPr>
          <p:cNvSpPr txBox="1"/>
          <p:nvPr/>
        </p:nvSpPr>
        <p:spPr>
          <a:xfrm rot="19800000">
            <a:off x="7892864" y="777126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 dirty="0"/>
              <a:t>MYB10.1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6265323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53</Words>
  <Application>Microsoft Office PowerPoint</Application>
  <PresentationFormat>Custom</PresentationFormat>
  <Paragraphs>2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Tema de 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Fiol, Arnau</cp:lastModifiedBy>
  <cp:revision>3</cp:revision>
  <dcterms:created xsi:type="dcterms:W3CDTF">2021-09-01T14:55:02Z</dcterms:created>
  <dcterms:modified xsi:type="dcterms:W3CDTF">2022-01-15T13:24:43Z</dcterms:modified>
</cp:coreProperties>
</file>